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6" r:id="rId5"/>
    <p:sldId id="257" r:id="rId6"/>
    <p:sldId id="258" r:id="rId7"/>
  </p:sldIdLst>
  <p:sldSz cx="6858000" cy="9144000" type="screen4x3"/>
  <p:notesSz cx="6794500" cy="9906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adège Bidan" initials="NB" lastIdx="1" clrIdx="0">
    <p:extLst>
      <p:ext uri="{19B8F6BF-5375-455C-9EA6-DF929625EA0E}">
        <p15:presenceInfo xmlns:p15="http://schemas.microsoft.com/office/powerpoint/2012/main" userId="S-1-5-21-4285973429-642659151-247001126-210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DB2AB84-DFA7-488B-932D-872E48BE6125}" v="2" dt="2022-12-15T10:48:42.51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15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Relationship Id="rId14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Yolande Misseri" userId="S::yolande.misseri@urosphere.com::ef38e326-f0d7-464f-a7bc-a259d337bc92" providerId="AD" clId="Web-{A4125372-AB6E-4E30-88F7-63AE152F639F}"/>
    <pc:docChg chg="modSld">
      <pc:chgData name="Yolande Misseri" userId="S::yolande.misseri@urosphere.com::ef38e326-f0d7-464f-a7bc-a259d337bc92" providerId="AD" clId="Web-{A4125372-AB6E-4E30-88F7-63AE152F639F}" dt="2022-10-25T14:14:45.757" v="149" actId="1076"/>
      <pc:docMkLst>
        <pc:docMk/>
      </pc:docMkLst>
      <pc:sldChg chg="addSp delSp modSp delCm">
        <pc:chgData name="Yolande Misseri" userId="S::yolande.misseri@urosphere.com::ef38e326-f0d7-464f-a7bc-a259d337bc92" providerId="AD" clId="Web-{A4125372-AB6E-4E30-88F7-63AE152F639F}" dt="2022-10-25T14:14:45.757" v="149" actId="1076"/>
        <pc:sldMkLst>
          <pc:docMk/>
          <pc:sldMk cId="549344984" sldId="256"/>
        </pc:sldMkLst>
        <pc:spChg chg="add mod">
          <ac:chgData name="Yolande Misseri" userId="S::yolande.misseri@urosphere.com::ef38e326-f0d7-464f-a7bc-a259d337bc92" providerId="AD" clId="Web-{A4125372-AB6E-4E30-88F7-63AE152F639F}" dt="2022-10-25T14:09:30.606" v="76" actId="1076"/>
          <ac:spMkLst>
            <pc:docMk/>
            <pc:sldMk cId="549344984" sldId="256"/>
            <ac:spMk id="3" creationId="{857D8518-180B-45EC-DA9A-D33D19D1465C}"/>
          </ac:spMkLst>
        </pc:spChg>
        <pc:spChg chg="add del mod">
          <ac:chgData name="Yolande Misseri" userId="S::yolande.misseri@urosphere.com::ef38e326-f0d7-464f-a7bc-a259d337bc92" providerId="AD" clId="Web-{A4125372-AB6E-4E30-88F7-63AE152F639F}" dt="2022-10-25T14:12:54.659" v="124"/>
          <ac:spMkLst>
            <pc:docMk/>
            <pc:sldMk cId="549344984" sldId="256"/>
            <ac:spMk id="4" creationId="{3CE78002-B0F6-D0F3-15B4-61583648C64E}"/>
          </ac:spMkLst>
        </pc:spChg>
        <pc:spChg chg="add del mod">
          <ac:chgData name="Yolande Misseri" userId="S::yolande.misseri@urosphere.com::ef38e326-f0d7-464f-a7bc-a259d337bc92" providerId="AD" clId="Web-{A4125372-AB6E-4E30-88F7-63AE152F639F}" dt="2022-10-25T14:13:27.567" v="132"/>
          <ac:spMkLst>
            <pc:docMk/>
            <pc:sldMk cId="549344984" sldId="256"/>
            <ac:spMk id="5" creationId="{8BC33008-F23B-2BEB-26DF-E5DBC68767BF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2:22.033" v="114" actId="1076"/>
          <ac:spMkLst>
            <pc:docMk/>
            <pc:sldMk cId="549344984" sldId="256"/>
            <ac:spMk id="6" creationId="{C029A88E-AD3E-7DC4-C811-6D996E6BF25A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2:44.753" v="121" actId="1076"/>
          <ac:spMkLst>
            <pc:docMk/>
            <pc:sldMk cId="549344984" sldId="256"/>
            <ac:spMk id="7" creationId="{D255CDF5-8708-2D24-5922-5F3763542391}"/>
          </ac:spMkLst>
        </pc:spChg>
        <pc:spChg chg="add">
          <ac:chgData name="Yolande Misseri" userId="S::yolande.misseri@urosphere.com::ef38e326-f0d7-464f-a7bc-a259d337bc92" providerId="AD" clId="Web-{A4125372-AB6E-4E30-88F7-63AE152F639F}" dt="2022-10-25T14:14:41.210" v="145"/>
          <ac:spMkLst>
            <pc:docMk/>
            <pc:sldMk cId="549344984" sldId="256"/>
            <ac:spMk id="8" creationId="{849B14EF-B857-35CC-5F3A-6C214EE82252}"/>
          </ac:spMkLst>
        </pc:spChg>
        <pc:spChg chg="add mod">
          <ac:chgData name="Yolande Misseri" userId="S::yolande.misseri@urosphere.com::ef38e326-f0d7-464f-a7bc-a259d337bc92" providerId="AD" clId="Web-{A4125372-AB6E-4E30-88F7-63AE152F639F}" dt="2022-10-25T14:14:45.757" v="149" actId="1076"/>
          <ac:spMkLst>
            <pc:docMk/>
            <pc:sldMk cId="549344984" sldId="256"/>
            <ac:spMk id="9" creationId="{849B14EF-B857-35CC-5F3A-6C214EE82252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48.474" v="135" actId="1076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07:11.288" v="48" actId="1076"/>
          <ac:spMkLst>
            <pc:docMk/>
            <pc:sldMk cId="549344984" sldId="256"/>
            <ac:spMk id="18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03.222" v="127" actId="1076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07:33.102" v="58" actId="1076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4:40.850" v="138" actId="1076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4125372-AB6E-4E30-88F7-63AE152F639F}" dt="2022-10-25T14:13:21.426" v="131" actId="1076"/>
          <ac:spMkLst>
            <pc:docMk/>
            <pc:sldMk cId="549344984" sldId="256"/>
            <ac:spMk id="28" creationId="{00000000-0000-0000-0000-000000000000}"/>
          </ac:spMkLst>
        </pc:spChg>
        <pc:picChg chg="add mod">
          <ac:chgData name="Yolande Misseri" userId="S::yolande.misseri@urosphere.com::ef38e326-f0d7-464f-a7bc-a259d337bc92" providerId="AD" clId="Web-{A4125372-AB6E-4E30-88F7-63AE152F639F}" dt="2022-10-25T14:04:00.766" v="4" actId="1076"/>
          <ac:picMkLst>
            <pc:docMk/>
            <pc:sldMk cId="549344984" sldId="256"/>
            <ac:picMk id="2" creationId="{5C05E02A-F5A5-E60A-77BA-055E17EA598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4:41.116" v="143" actId="1076"/>
          <ac:picMkLst>
            <pc:docMk/>
            <pc:sldMk cId="549344984" sldId="256"/>
            <ac:picMk id="15" creationId="{00000000-0000-0000-0000-000000000000}"/>
          </ac:picMkLst>
        </pc:picChg>
        <pc:picChg chg="mod ord">
          <ac:chgData name="Yolande Misseri" userId="S::yolande.misseri@urosphere.com::ef38e326-f0d7-464f-a7bc-a259d337bc92" providerId="AD" clId="Web-{A4125372-AB6E-4E30-88F7-63AE152F639F}" dt="2022-10-25T14:11:56.907" v="107" actId="1076"/>
          <ac:picMkLst>
            <pc:docMk/>
            <pc:sldMk cId="549344984" sldId="256"/>
            <ac:picMk id="22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4:41.147" v="144" actId="1076"/>
          <ac:picMkLst>
            <pc:docMk/>
            <pc:sldMk cId="549344984" sldId="256"/>
            <ac:picMk id="25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4125372-AB6E-4E30-88F7-63AE152F639F}" dt="2022-10-25T14:11:56.954" v="108" actId="1076"/>
          <ac:picMkLst>
            <pc:docMk/>
            <pc:sldMk cId="549344984" sldId="256"/>
            <ac:picMk id="27" creationId="{00000000-0000-0000-0000-000000000000}"/>
          </ac:picMkLst>
        </pc:picChg>
      </pc:sldChg>
    </pc:docChg>
  </pc:docChgLst>
  <pc:docChgLst>
    <pc:chgData name="Claire Beraud" userId="S::claire.beraud@urosphere.com::88d8f020-165f-4369-a606-bc2a6e18c31d" providerId="AD" clId="Web-{8EA13D2C-2176-4C2A-BF40-8DC88972A67D}"/>
    <pc:docChg chg="modSld">
      <pc:chgData name="Claire Beraud" userId="S::claire.beraud@urosphere.com::88d8f020-165f-4369-a606-bc2a6e18c31d" providerId="AD" clId="Web-{8EA13D2C-2176-4C2A-BF40-8DC88972A67D}" dt="2022-12-12T14:45:48.745" v="3" actId="20577"/>
      <pc:docMkLst>
        <pc:docMk/>
      </pc:docMkLst>
      <pc:sldChg chg="modSp">
        <pc:chgData name="Claire Beraud" userId="S::claire.beraud@urosphere.com::88d8f020-165f-4369-a606-bc2a6e18c31d" providerId="AD" clId="Web-{8EA13D2C-2176-4C2A-BF40-8DC88972A67D}" dt="2022-12-12T14:45:48.745" v="3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8EA13D2C-2176-4C2A-BF40-8DC88972A67D}" dt="2022-12-12T14:45:48.745" v="3" actId="20577"/>
          <ac:spMkLst>
            <pc:docMk/>
            <pc:sldMk cId="549344984" sldId="256"/>
            <ac:spMk id="12" creationId="{00000000-0000-0000-0000-000000000000}"/>
          </ac:spMkLst>
        </pc:spChg>
      </pc:sldChg>
    </pc:docChg>
  </pc:docChgLst>
  <pc:docChgLst>
    <pc:chgData name="Claire Beraud" userId="S::claire.beraud@urosphere.com::88d8f020-165f-4369-a606-bc2a6e18c31d" providerId="AD" clId="Web-{EF8D19B8-AC61-4B73-8550-3AFB7453DD54}"/>
    <pc:docChg chg="modSld">
      <pc:chgData name="Claire Beraud" userId="S::claire.beraud@urosphere.com::88d8f020-165f-4369-a606-bc2a6e18c31d" providerId="AD" clId="Web-{EF8D19B8-AC61-4B73-8550-3AFB7453DD54}" dt="2022-12-12T14:40:11.018" v="7" actId="20577"/>
      <pc:docMkLst>
        <pc:docMk/>
      </pc:docMkLst>
      <pc:sldChg chg="modSp">
        <pc:chgData name="Claire Beraud" userId="S::claire.beraud@urosphere.com::88d8f020-165f-4369-a606-bc2a6e18c31d" providerId="AD" clId="Web-{EF8D19B8-AC61-4B73-8550-3AFB7453DD54}" dt="2022-12-12T14:39:49.486" v="2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EF8D19B8-AC61-4B73-8550-3AFB7453DD54}" dt="2022-12-12T14:39:49.486" v="2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EF8D19B8-AC61-4B73-8550-3AFB7453DD54}" dt="2022-12-12T14:40:11.018" v="7" actId="20577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EF8D19B8-AC61-4B73-8550-3AFB7453DD54}" dt="2022-12-12T14:40:11.018" v="7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EF8D19B8-AC61-4B73-8550-3AFB7453DD54}" dt="2022-12-12T14:40:03.814" v="6" actId="20577"/>
        <pc:sldMkLst>
          <pc:docMk/>
          <pc:sldMk cId="1560682878" sldId="258"/>
        </pc:sldMkLst>
        <pc:spChg chg="mod">
          <ac:chgData name="Claire Beraud" userId="S::claire.beraud@urosphere.com::88d8f020-165f-4369-a606-bc2a6e18c31d" providerId="AD" clId="Web-{EF8D19B8-AC61-4B73-8550-3AFB7453DD54}" dt="2022-12-12T14:40:03.814" v="6" actId="20577"/>
          <ac:spMkLst>
            <pc:docMk/>
            <pc:sldMk cId="1560682878" sldId="258"/>
            <ac:spMk id="5" creationId="{00000000-0000-0000-0000-000000000000}"/>
          </ac:spMkLst>
        </pc:spChg>
      </pc:sldChg>
    </pc:docChg>
  </pc:docChgLst>
  <pc:docChgLst>
    <pc:chgData name="Claire Beraud" userId="S::claire.beraud@urosphere.com::88d8f020-165f-4369-a606-bc2a6e18c31d" providerId="AD" clId="Web-{C0E9897B-ACEF-4045-991C-CAC76D9F356B}"/>
    <pc:docChg chg="modSld">
      <pc:chgData name="Claire Beraud" userId="S::claire.beraud@urosphere.com::88d8f020-165f-4369-a606-bc2a6e18c31d" providerId="AD" clId="Web-{C0E9897B-ACEF-4045-991C-CAC76D9F356B}" dt="2022-11-11T13:37:23.728" v="19" actId="14100"/>
      <pc:docMkLst>
        <pc:docMk/>
      </pc:docMkLst>
      <pc:sldChg chg="modSp">
        <pc:chgData name="Claire Beraud" userId="S::claire.beraud@urosphere.com::88d8f020-165f-4369-a606-bc2a6e18c31d" providerId="AD" clId="Web-{C0E9897B-ACEF-4045-991C-CAC76D9F356B}" dt="2022-11-11T13:36:23.289" v="2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C0E9897B-ACEF-4045-991C-CAC76D9F356B}" dt="2022-11-11T13:36:23.289" v="2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C0E9897B-ACEF-4045-991C-CAC76D9F356B}" dt="2022-11-11T13:36:37.867" v="5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C0E9897B-ACEF-4045-991C-CAC76D9F356B}" dt="2022-11-11T13:36:37.867" v="5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C0E9897B-ACEF-4045-991C-CAC76D9F356B}" dt="2022-11-11T13:37:23.728" v="19" actId="14100"/>
        <pc:sldMkLst>
          <pc:docMk/>
          <pc:sldMk cId="1560682878" sldId="258"/>
        </pc:sldMkLst>
        <pc:spChg chg="mod">
          <ac:chgData name="Claire Beraud" userId="S::claire.beraud@urosphere.com::88d8f020-165f-4369-a606-bc2a6e18c31d" providerId="AD" clId="Web-{C0E9897B-ACEF-4045-991C-CAC76D9F356B}" dt="2022-11-11T13:37:23.728" v="19" actId="14100"/>
          <ac:spMkLst>
            <pc:docMk/>
            <pc:sldMk cId="1560682878" sldId="258"/>
            <ac:spMk id="5" creationId="{00000000-0000-0000-0000-000000000000}"/>
          </ac:spMkLst>
        </pc:spChg>
      </pc:sldChg>
    </pc:docChg>
  </pc:docChgLst>
  <pc:docChgLst>
    <pc:chgData name="Yolande Misseri" userId="S::yolande.misseri@urosphere.com::ef38e326-f0d7-464f-a7bc-a259d337bc92" providerId="AD" clId="Web-{A7DC46CC-884E-4C74-9339-3D9410B73A80}"/>
    <pc:docChg chg="modSld">
      <pc:chgData name="Yolande Misseri" userId="S::yolande.misseri@urosphere.com::ef38e326-f0d7-464f-a7bc-a259d337bc92" providerId="AD" clId="Web-{A7DC46CC-884E-4C74-9339-3D9410B73A80}" dt="2022-10-25T15:04:31.964" v="112"/>
      <pc:docMkLst>
        <pc:docMk/>
      </pc:docMkLst>
      <pc:sldChg chg="addSp delSp modSp">
        <pc:chgData name="Yolande Misseri" userId="S::yolande.misseri@urosphere.com::ef38e326-f0d7-464f-a7bc-a259d337bc92" providerId="AD" clId="Web-{A7DC46CC-884E-4C74-9339-3D9410B73A80}" dt="2022-10-25T15:04:31.964" v="112"/>
        <pc:sldMkLst>
          <pc:docMk/>
          <pc:sldMk cId="549344984" sldId="256"/>
        </pc:sldMkLst>
        <pc:spChg chg="mod">
          <ac:chgData name="Yolande Misseri" userId="S::yolande.misseri@urosphere.com::ef38e326-f0d7-464f-a7bc-a259d337bc92" providerId="AD" clId="Web-{A7DC46CC-884E-4C74-9339-3D9410B73A80}" dt="2022-10-25T14:52:51.725" v="18" actId="1076"/>
          <ac:spMkLst>
            <pc:docMk/>
            <pc:sldMk cId="549344984" sldId="256"/>
            <ac:spMk id="3" creationId="{857D8518-180B-45EC-DA9A-D33D19D1465C}"/>
          </ac:spMkLst>
        </pc:spChg>
        <pc:spChg chg="add del mod">
          <ac:chgData name="Yolande Misseri" userId="S::yolande.misseri@urosphere.com::ef38e326-f0d7-464f-a7bc-a259d337bc92" providerId="AD" clId="Web-{A7DC46CC-884E-4C74-9339-3D9410B73A80}" dt="2022-10-25T14:51:41.833" v="11"/>
          <ac:spMkLst>
            <pc:docMk/>
            <pc:sldMk cId="549344984" sldId="256"/>
            <ac:spMk id="4" creationId="{9A80E326-6BC0-B651-13D9-6BE45641C1AB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4:53:06.491" v="21" actId="1076"/>
          <ac:spMkLst>
            <pc:docMk/>
            <pc:sldMk cId="549344984" sldId="256"/>
            <ac:spMk id="5" creationId="{700D85AB-4877-1F69-F402-907B32C7F93F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26" v="68" actId="1076"/>
          <ac:spMkLst>
            <pc:docMk/>
            <pc:sldMk cId="549344984" sldId="256"/>
            <ac:spMk id="6" creationId="{C029A88E-AD3E-7DC4-C811-6D996E6BF25A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42" v="69" actId="1076"/>
          <ac:spMkLst>
            <pc:docMk/>
            <pc:sldMk cId="549344984" sldId="256"/>
            <ac:spMk id="7" creationId="{D255CDF5-8708-2D24-5922-5F3763542391}"/>
          </ac:spMkLst>
        </pc:spChg>
        <pc:spChg chg="del">
          <ac:chgData name="Yolande Misseri" userId="S::yolande.misseri@urosphere.com::ef38e326-f0d7-464f-a7bc-a259d337bc92" providerId="AD" clId="Web-{A7DC46CC-884E-4C74-9339-3D9410B73A80}" dt="2022-10-25T14:51:00.191" v="4"/>
          <ac:spMkLst>
            <pc:docMk/>
            <pc:sldMk cId="549344984" sldId="256"/>
            <ac:spMk id="8" creationId="{849B14EF-B857-35CC-5F3A-6C214EE82252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43.458" v="70" actId="1076"/>
          <ac:spMkLst>
            <pc:docMk/>
            <pc:sldMk cId="549344984" sldId="256"/>
            <ac:spMk id="9" creationId="{849B14EF-B857-35CC-5F3A-6C214EE82252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473" v="71" actId="1076"/>
          <ac:spMkLst>
            <pc:docMk/>
            <pc:sldMk cId="549344984" sldId="256"/>
            <ac:spMk id="10" creationId="{A94F8EF2-07A7-B1C6-CEF2-E3F67962CDD2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489" v="72" actId="1076"/>
          <ac:spMkLst>
            <pc:docMk/>
            <pc:sldMk cId="549344984" sldId="256"/>
            <ac:spMk id="11" creationId="{D6D9CEE8-B12A-56EC-334F-0B625ECE596C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0:43.504" v="73" actId="1076"/>
          <ac:spMkLst>
            <pc:docMk/>
            <pc:sldMk cId="549344984" sldId="256"/>
            <ac:spMk id="13" creationId="{9268B0B7-CB92-B617-A633-356E397199B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01.817" v="75" actId="1076"/>
          <ac:spMkLst>
            <pc:docMk/>
            <pc:sldMk cId="549344984" sldId="256"/>
            <ac:spMk id="14" creationId="{DA3AFC02-A95A-8CB1-E31D-5C8B73ED8BA1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13.160" v="66" actId="1076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5:33.917" v="48" actId="1076"/>
          <ac:spMkLst>
            <pc:docMk/>
            <pc:sldMk cId="549344984" sldId="256"/>
            <ac:spMk id="18" creationId="{00000000-0000-0000-0000-0000000000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09.427" v="77" actId="1076"/>
          <ac:spMkLst>
            <pc:docMk/>
            <pc:sldMk cId="549344984" sldId="256"/>
            <ac:spMk id="19" creationId="{97421630-486A-7F31-A1D9-321E89CE94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22.084" v="80" actId="1076"/>
          <ac:spMkLst>
            <pc:docMk/>
            <pc:sldMk cId="549344984" sldId="256"/>
            <ac:spMk id="20" creationId="{6590D960-F6A7-DD65-F7D0-E989A7CFBBAE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5:00:13.175" v="67" actId="1076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53" v="63" actId="1076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69" v="65" actId="1076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Yolande Misseri" userId="S::yolande.misseri@urosphere.com::ef38e326-f0d7-464f-a7bc-a259d337bc92" providerId="AD" clId="Web-{A7DC46CC-884E-4C74-9339-3D9410B73A80}" dt="2022-10-25T14:59:57.769" v="64" actId="1076"/>
          <ac:spMkLst>
            <pc:docMk/>
            <pc:sldMk cId="549344984" sldId="256"/>
            <ac:spMk id="28" creationId="{00000000-0000-0000-0000-000000000000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1:55.272" v="84" actId="1076"/>
          <ac:spMkLst>
            <pc:docMk/>
            <pc:sldMk cId="549344984" sldId="256"/>
            <ac:spMk id="29" creationId="{0659AA26-F55C-7D17-76D6-3CB0FAD5B0CA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19.337" v="99" actId="1076"/>
          <ac:spMkLst>
            <pc:docMk/>
            <pc:sldMk cId="549344984" sldId="256"/>
            <ac:spMk id="30" creationId="{68EFCF1E-3CCA-EDB9-B6D7-F6E3F21E43CC}"/>
          </ac:spMkLst>
        </pc:spChg>
        <pc:spChg chg="add del">
          <ac:chgData name="Yolande Misseri" userId="S::yolande.misseri@urosphere.com::ef38e326-f0d7-464f-a7bc-a259d337bc92" providerId="AD" clId="Web-{A7DC46CC-884E-4C74-9339-3D9410B73A80}" dt="2022-10-25T15:04:31.964" v="112"/>
          <ac:spMkLst>
            <pc:docMk/>
            <pc:sldMk cId="549344984" sldId="256"/>
            <ac:spMk id="31" creationId="{DDF9A4A6-987B-18DA-C848-4C0506E12805}"/>
          </ac:spMkLst>
        </pc:spChg>
        <pc:spChg chg="add del">
          <ac:chgData name="Yolande Misseri" userId="S::yolande.misseri@urosphere.com::ef38e326-f0d7-464f-a7bc-a259d337bc92" providerId="AD" clId="Web-{A7DC46CC-884E-4C74-9339-3D9410B73A80}" dt="2022-10-25T15:04:29.917" v="111"/>
          <ac:spMkLst>
            <pc:docMk/>
            <pc:sldMk cId="549344984" sldId="256"/>
            <ac:spMk id="32" creationId="{51C91AC7-1BE0-2519-9D0E-87C1CA1BC6CD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25.478" v="100" actId="1076"/>
          <ac:spMkLst>
            <pc:docMk/>
            <pc:sldMk cId="549344984" sldId="256"/>
            <ac:spMk id="33" creationId="{B6287CF4-FA73-69A3-1406-3DCC8E451B47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3:52.291" v="104" actId="14100"/>
          <ac:spMkLst>
            <pc:docMk/>
            <pc:sldMk cId="549344984" sldId="256"/>
            <ac:spMk id="34" creationId="{636251B6-B871-3CBF-A8FD-352DA405EDBB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01.651" v="106" actId="1076"/>
          <ac:spMkLst>
            <pc:docMk/>
            <pc:sldMk cId="549344984" sldId="256"/>
            <ac:spMk id="35" creationId="{FBE6016B-D58F-F2F7-CEBF-129A2A8A8CD3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09.401" v="108" actId="1076"/>
          <ac:spMkLst>
            <pc:docMk/>
            <pc:sldMk cId="549344984" sldId="256"/>
            <ac:spMk id="36" creationId="{50D88616-593B-A5F3-4900-C2863A4E4548}"/>
          </ac:spMkLst>
        </pc:spChg>
        <pc:spChg chg="add mod">
          <ac:chgData name="Yolande Misseri" userId="S::yolande.misseri@urosphere.com::ef38e326-f0d7-464f-a7bc-a259d337bc92" providerId="AD" clId="Web-{A7DC46CC-884E-4C74-9339-3D9410B73A80}" dt="2022-10-25T15:04:22.433" v="110" actId="1076"/>
          <ac:spMkLst>
            <pc:docMk/>
            <pc:sldMk cId="549344984" sldId="256"/>
            <ac:spMk id="37" creationId="{5D73F1C0-2C4B-0A17-7DCD-A63F4314C723}"/>
          </ac:spMkLst>
        </pc:spChg>
        <pc:picChg chg="mod">
          <ac:chgData name="Yolande Misseri" userId="S::yolande.misseri@urosphere.com::ef38e326-f0d7-464f-a7bc-a259d337bc92" providerId="AD" clId="Web-{A7DC46CC-884E-4C74-9339-3D9410B73A80}" dt="2022-10-25T14:53:35.727" v="26" actId="1076"/>
          <ac:picMkLst>
            <pc:docMk/>
            <pc:sldMk cId="549344984" sldId="256"/>
            <ac:picMk id="17" creationId="{00000000-0000-0000-0000-000000000000}"/>
          </ac:picMkLst>
        </pc:picChg>
        <pc:picChg chg="mod">
          <ac:chgData name="Yolande Misseri" userId="S::yolande.misseri@urosphere.com::ef38e326-f0d7-464f-a7bc-a259d337bc92" providerId="AD" clId="Web-{A7DC46CC-884E-4C74-9339-3D9410B73A80}" dt="2022-10-25T14:53:35.758" v="27" actId="1076"/>
          <ac:picMkLst>
            <pc:docMk/>
            <pc:sldMk cId="549344984" sldId="256"/>
            <ac:picMk id="23" creationId="{00000000-0000-0000-0000-000000000000}"/>
          </ac:picMkLst>
        </pc:picChg>
      </pc:sldChg>
    </pc:docChg>
  </pc:docChgLst>
  <pc:docChgLst>
    <pc:chgData name="Claire Beraud" userId="S::claire.beraud@urosphere.com::88d8f020-165f-4369-a606-bc2a6e18c31d" providerId="AD" clId="Web-{D4962F37-612E-4C94-8FD5-E4D225F1D387}"/>
    <pc:docChg chg="modSld">
      <pc:chgData name="Claire Beraud" userId="S::claire.beraud@urosphere.com::88d8f020-165f-4369-a606-bc2a6e18c31d" providerId="AD" clId="Web-{D4962F37-612E-4C94-8FD5-E4D225F1D387}" dt="2022-10-20T15:00:20.454" v="15" actId="20577"/>
      <pc:docMkLst>
        <pc:docMk/>
      </pc:docMkLst>
      <pc:sldChg chg="modSp">
        <pc:chgData name="Claire Beraud" userId="S::claire.beraud@urosphere.com::88d8f020-165f-4369-a606-bc2a6e18c31d" providerId="AD" clId="Web-{D4962F37-612E-4C94-8FD5-E4D225F1D387}" dt="2022-10-20T14:59:47.031" v="11" actId="20577"/>
        <pc:sldMkLst>
          <pc:docMk/>
          <pc:sldMk cId="549344984" sldId="256"/>
        </pc:sldMkLst>
        <pc:spChg chg="mod">
          <ac:chgData name="Claire Beraud" userId="S::claire.beraud@urosphere.com::88d8f020-165f-4369-a606-bc2a6e18c31d" providerId="AD" clId="Web-{D4962F37-612E-4C94-8FD5-E4D225F1D387}" dt="2022-10-20T14:59:47.031" v="11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D4962F37-612E-4C94-8FD5-E4D225F1D387}" dt="2022-10-20T15:00:20.454" v="15" actId="20577"/>
        <pc:sldMkLst>
          <pc:docMk/>
          <pc:sldMk cId="2653623170" sldId="257"/>
        </pc:sldMkLst>
        <pc:spChg chg="mod">
          <ac:chgData name="Claire Beraud" userId="S::claire.beraud@urosphere.com::88d8f020-165f-4369-a606-bc2a6e18c31d" providerId="AD" clId="Web-{D4962F37-612E-4C94-8FD5-E4D225F1D387}" dt="2022-10-20T15:00:20.454" v="15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">
        <pc:chgData name="Claire Beraud" userId="S::claire.beraud@urosphere.com::88d8f020-165f-4369-a606-bc2a6e18c31d" providerId="AD" clId="Web-{D4962F37-612E-4C94-8FD5-E4D225F1D387}" dt="2022-10-20T15:00:19.032" v="14" actId="14100"/>
        <pc:sldMkLst>
          <pc:docMk/>
          <pc:sldMk cId="1560682878" sldId="258"/>
        </pc:sldMkLst>
        <pc:picChg chg="mod">
          <ac:chgData name="Claire Beraud" userId="S::claire.beraud@urosphere.com::88d8f020-165f-4369-a606-bc2a6e18c31d" providerId="AD" clId="Web-{D4962F37-612E-4C94-8FD5-E4D225F1D387}" dt="2022-10-20T15:00:19.032" v="14" actId="14100"/>
          <ac:picMkLst>
            <pc:docMk/>
            <pc:sldMk cId="1560682878" sldId="258"/>
            <ac:picMk id="6" creationId="{59E6289B-6F7D-49DC-9769-4C7CAE5ACB94}"/>
          </ac:picMkLst>
        </pc:picChg>
      </pc:sldChg>
    </pc:docChg>
  </pc:docChgLst>
  <pc:docChgLst>
    <pc:chgData name="Nadege Bidan" userId="101290c6-d7fd-4e4f-abb4-82cb3a45689d" providerId="ADAL" clId="{ADB2AB84-DFA7-488B-932D-872E48BE6125}"/>
    <pc:docChg chg="custSel delSld modSld">
      <pc:chgData name="Nadege Bidan" userId="101290c6-d7fd-4e4f-abb4-82cb3a45689d" providerId="ADAL" clId="{ADB2AB84-DFA7-488B-932D-872E48BE6125}" dt="2022-12-15T10:50:12.789" v="34" actId="1037"/>
      <pc:docMkLst>
        <pc:docMk/>
      </pc:docMkLst>
      <pc:sldChg chg="addSp delSp modSp mod">
        <pc:chgData name="Nadege Bidan" userId="101290c6-d7fd-4e4f-abb4-82cb3a45689d" providerId="ADAL" clId="{ADB2AB84-DFA7-488B-932D-872E48BE6125}" dt="2022-12-15T10:48:25.707" v="8" actId="20577"/>
        <pc:sldMkLst>
          <pc:docMk/>
          <pc:sldMk cId="549344984" sldId="256"/>
        </pc:sldMkLst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" creationId="{857D8518-180B-45EC-DA9A-D33D19D1465C}"/>
          </ac:spMkLst>
        </pc:spChg>
        <pc:spChg chg="add mod">
          <ac:chgData name="Nadege Bidan" userId="101290c6-d7fd-4e4f-abb4-82cb3a45689d" providerId="ADAL" clId="{ADB2AB84-DFA7-488B-932D-872E48BE6125}" dt="2022-12-15T10:48:25.707" v="8" actId="20577"/>
          <ac:spMkLst>
            <pc:docMk/>
            <pc:sldMk cId="549344984" sldId="256"/>
            <ac:spMk id="4" creationId="{6391E0BF-9B58-1F6E-8992-C142CB3BBD3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5" creationId="{700D85AB-4877-1F69-F402-907B32C7F93F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6" creationId="{C029A88E-AD3E-7DC4-C811-6D996E6BF25A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7" creationId="{D255CDF5-8708-2D24-5922-5F376354239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9" creationId="{849B14EF-B857-35CC-5F3A-6C214EE82252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0" creationId="{A94F8EF2-07A7-B1C6-CEF2-E3F67962CDD2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1" creationId="{D6D9CEE8-B12A-56EC-334F-0B625ECE596C}"/>
          </ac:spMkLst>
        </pc:spChg>
        <pc:spChg chg="del mod">
          <ac:chgData name="Nadege Bidan" userId="101290c6-d7fd-4e4f-abb4-82cb3a45689d" providerId="ADAL" clId="{ADB2AB84-DFA7-488B-932D-872E48BE6125}" dt="2022-12-15T10:47:42.290" v="1" actId="478"/>
          <ac:spMkLst>
            <pc:docMk/>
            <pc:sldMk cId="549344984" sldId="256"/>
            <ac:spMk id="12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3" creationId="{9268B0B7-CB92-B617-A633-356E397199B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4" creationId="{DA3AFC02-A95A-8CB1-E31D-5C8B73ED8BA1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6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19" creationId="{97421630-486A-7F31-A1D9-321E89CE94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0" creationId="{6590D960-F6A7-DD65-F7D0-E989A7CFBBAE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1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4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6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29" creationId="{0659AA26-F55C-7D17-76D6-3CB0FAD5B0CA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0" creationId="{68EFCF1E-3CCA-EDB9-B6D7-F6E3F21E43CC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3" creationId="{B6287CF4-FA73-69A3-1406-3DCC8E451B47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4" creationId="{636251B6-B871-3CBF-A8FD-352DA405EDBB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5" creationId="{FBE6016B-D58F-F2F7-CEBF-129A2A8A8CD3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6" creationId="{50D88616-593B-A5F3-4900-C2863A4E4548}"/>
          </ac:spMkLst>
        </pc:spChg>
        <pc:spChg chg="mod">
          <ac:chgData name="Nadege Bidan" userId="101290c6-d7fd-4e4f-abb4-82cb3a45689d" providerId="ADAL" clId="{ADB2AB84-DFA7-488B-932D-872E48BE6125}" dt="2022-12-15T10:47:39.156" v="0" actId="2711"/>
          <ac:spMkLst>
            <pc:docMk/>
            <pc:sldMk cId="549344984" sldId="256"/>
            <ac:spMk id="37" creationId="{5D73F1C0-2C4B-0A17-7DCD-A63F4314C723}"/>
          </ac:spMkLst>
        </pc:spChg>
      </pc:sldChg>
      <pc:sldChg chg="modSp mod">
        <pc:chgData name="Nadege Bidan" userId="101290c6-d7fd-4e4f-abb4-82cb3a45689d" providerId="ADAL" clId="{ADB2AB84-DFA7-488B-932D-872E48BE6125}" dt="2022-12-15T10:50:12.789" v="34" actId="1037"/>
        <pc:sldMkLst>
          <pc:docMk/>
          <pc:sldMk cId="2653623170" sldId="257"/>
        </pc:sldMkLst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2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48:33.620" v="16" actId="1035"/>
          <ac:spMkLst>
            <pc:docMk/>
            <pc:sldMk cId="2653623170" sldId="257"/>
            <ac:spMk id="10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3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5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8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19" creationId="{00000000-0000-0000-0000-000000000000}"/>
          </ac:spMkLst>
        </pc:spChg>
        <pc:spChg chg="mod">
          <ac:chgData name="Nadege Bidan" userId="101290c6-d7fd-4e4f-abb4-82cb3a45689d" providerId="ADAL" clId="{ADB2AB84-DFA7-488B-932D-872E48BE6125}" dt="2022-12-15T10:50:12.789" v="34" actId="1037"/>
          <ac:spMkLst>
            <pc:docMk/>
            <pc:sldMk cId="2653623170" sldId="257"/>
            <ac:spMk id="20" creationId="{00000000-0000-0000-0000-000000000000}"/>
          </ac:spMkLst>
        </pc:sp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6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1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2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4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6" creationId="{00000000-0000-0000-0000-000000000000}"/>
          </ac:picMkLst>
        </pc:picChg>
        <pc:picChg chg="mod">
          <ac:chgData name="Nadege Bidan" userId="101290c6-d7fd-4e4f-abb4-82cb3a45689d" providerId="ADAL" clId="{ADB2AB84-DFA7-488B-932D-872E48BE6125}" dt="2022-12-15T10:50:12.789" v="34" actId="1037"/>
          <ac:picMkLst>
            <pc:docMk/>
            <pc:sldMk cId="2653623170" sldId="257"/>
            <ac:picMk id="17" creationId="{00000000-0000-0000-0000-000000000000}"/>
          </ac:picMkLst>
        </pc:picChg>
      </pc:sldChg>
      <pc:sldChg chg="addSp delSp modSp mod">
        <pc:chgData name="Nadege Bidan" userId="101290c6-d7fd-4e4f-abb4-82cb3a45689d" providerId="ADAL" clId="{ADB2AB84-DFA7-488B-932D-872E48BE6125}" dt="2022-12-15T10:48:47.461" v="20" actId="20577"/>
        <pc:sldMkLst>
          <pc:docMk/>
          <pc:sldMk cId="1560682878" sldId="258"/>
        </pc:sldMkLst>
        <pc:spChg chg="add mod">
          <ac:chgData name="Nadege Bidan" userId="101290c6-d7fd-4e4f-abb4-82cb3a45689d" providerId="ADAL" clId="{ADB2AB84-DFA7-488B-932D-872E48BE6125}" dt="2022-12-15T10:48:47.461" v="20" actId="20577"/>
          <ac:spMkLst>
            <pc:docMk/>
            <pc:sldMk cId="1560682878" sldId="258"/>
            <ac:spMk id="2" creationId="{986B2059-3DB8-6A20-303F-47AD06C93889}"/>
          </ac:spMkLst>
        </pc:spChg>
        <pc:spChg chg="del">
          <ac:chgData name="Nadege Bidan" userId="101290c6-d7fd-4e4f-abb4-82cb3a45689d" providerId="ADAL" clId="{ADB2AB84-DFA7-488B-932D-872E48BE6125}" dt="2022-12-15T10:48:42.108" v="17" actId="478"/>
          <ac:spMkLst>
            <pc:docMk/>
            <pc:sldMk cId="1560682878" sldId="258"/>
            <ac:spMk id="5" creationId="{00000000-0000-0000-0000-000000000000}"/>
          </ac:spMkLst>
        </pc:spChg>
      </pc:sldChg>
      <pc:sldChg chg="del">
        <pc:chgData name="Nadege Bidan" userId="101290c6-d7fd-4e4f-abb4-82cb3a45689d" providerId="ADAL" clId="{ADB2AB84-DFA7-488B-932D-872E48BE6125}" dt="2022-12-15T10:50:04.172" v="21" actId="47"/>
        <pc:sldMkLst>
          <pc:docMk/>
          <pc:sldMk cId="3734547398" sldId="259"/>
        </pc:sldMkLst>
      </pc:sldChg>
    </pc:docChg>
  </pc:docChgLst>
  <pc:docChgLst>
    <pc:chgData name="Nadege Bidan" userId="101290c6-d7fd-4e4f-abb4-82cb3a45689d" providerId="ADAL" clId="{96C1BEDC-0F4B-477D-AC7F-184F8163FACF}"/>
    <pc:docChg chg="modSld">
      <pc:chgData name="Nadege Bidan" userId="101290c6-d7fd-4e4f-abb4-82cb3a45689d" providerId="ADAL" clId="{96C1BEDC-0F4B-477D-AC7F-184F8163FACF}" dt="2022-12-08T07:02:15.120" v="13" actId="20577"/>
      <pc:docMkLst>
        <pc:docMk/>
      </pc:docMkLst>
      <pc:sldChg chg="modSp mod">
        <pc:chgData name="Nadege Bidan" userId="101290c6-d7fd-4e4f-abb4-82cb3a45689d" providerId="ADAL" clId="{96C1BEDC-0F4B-477D-AC7F-184F8163FACF}" dt="2022-12-08T07:01:28.571" v="1" actId="20577"/>
        <pc:sldMkLst>
          <pc:docMk/>
          <pc:sldMk cId="549344984" sldId="256"/>
        </pc:sldMkLst>
        <pc:spChg chg="mod">
          <ac:chgData name="Nadege Bidan" userId="101290c6-d7fd-4e4f-abb4-82cb3a45689d" providerId="ADAL" clId="{96C1BEDC-0F4B-477D-AC7F-184F8163FACF}" dt="2022-12-08T07:01:28.571" v="1" actId="20577"/>
          <ac:spMkLst>
            <pc:docMk/>
            <pc:sldMk cId="549344984" sldId="256"/>
            <ac:spMk id="12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1:40.886" v="3" actId="20577"/>
        <pc:sldMkLst>
          <pc:docMk/>
          <pc:sldMk cId="2653623170" sldId="257"/>
        </pc:sldMkLst>
        <pc:spChg chg="mod">
          <ac:chgData name="Nadege Bidan" userId="101290c6-d7fd-4e4f-abb4-82cb3a45689d" providerId="ADAL" clId="{96C1BEDC-0F4B-477D-AC7F-184F8163FACF}" dt="2022-12-08T07:01:40.886" v="3" actId="20577"/>
          <ac:spMkLst>
            <pc:docMk/>
            <pc:sldMk cId="2653623170" sldId="257"/>
            <ac:spMk id="10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1:50.849" v="5" actId="20577"/>
        <pc:sldMkLst>
          <pc:docMk/>
          <pc:sldMk cId="1560682878" sldId="258"/>
        </pc:sldMkLst>
        <pc:spChg chg="mod">
          <ac:chgData name="Nadege Bidan" userId="101290c6-d7fd-4e4f-abb4-82cb3a45689d" providerId="ADAL" clId="{96C1BEDC-0F4B-477D-AC7F-184F8163FACF}" dt="2022-12-08T07:01:50.849" v="5" actId="20577"/>
          <ac:spMkLst>
            <pc:docMk/>
            <pc:sldMk cId="1560682878" sldId="258"/>
            <ac:spMk id="5" creationId="{00000000-0000-0000-0000-000000000000}"/>
          </ac:spMkLst>
        </pc:spChg>
      </pc:sldChg>
      <pc:sldChg chg="modSp mod">
        <pc:chgData name="Nadege Bidan" userId="101290c6-d7fd-4e4f-abb4-82cb3a45689d" providerId="ADAL" clId="{96C1BEDC-0F4B-477D-AC7F-184F8163FACF}" dt="2022-12-08T07:02:15.120" v="13" actId="20577"/>
        <pc:sldMkLst>
          <pc:docMk/>
          <pc:sldMk cId="3734547398" sldId="259"/>
        </pc:sldMkLst>
        <pc:spChg chg="mod">
          <ac:chgData name="Nadege Bidan" userId="101290c6-d7fd-4e4f-abb4-82cb3a45689d" providerId="ADAL" clId="{96C1BEDC-0F4B-477D-AC7F-184F8163FACF}" dt="2022-12-08T07:02:15.120" v="13" actId="20577"/>
          <ac:spMkLst>
            <pc:docMk/>
            <pc:sldMk cId="3734547398" sldId="259"/>
            <ac:spMk id="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5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91" indent="0" algn="ctr">
              <a:buNone/>
              <a:defRPr sz="1500"/>
            </a:lvl2pPr>
            <a:lvl3pPr marL="685783" indent="0" algn="ctr">
              <a:buNone/>
              <a:defRPr sz="1351"/>
            </a:lvl3pPr>
            <a:lvl4pPr marL="1028674" indent="0" algn="ctr">
              <a:buNone/>
              <a:defRPr sz="1200"/>
            </a:lvl4pPr>
            <a:lvl5pPr marL="1371566" indent="0" algn="ctr">
              <a:buNone/>
              <a:defRPr sz="1200"/>
            </a:lvl5pPr>
            <a:lvl6pPr marL="1714457" indent="0" algn="ctr">
              <a:buNone/>
              <a:defRPr sz="1200"/>
            </a:lvl6pPr>
            <a:lvl7pPr marL="2057349" indent="0" algn="ctr">
              <a:buNone/>
              <a:defRPr sz="1200"/>
            </a:lvl7pPr>
            <a:lvl8pPr marL="2400240" indent="0" algn="ctr">
              <a:buNone/>
              <a:defRPr sz="1200"/>
            </a:lvl8pPr>
            <a:lvl9pPr marL="2743131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3653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14937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486835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9" y="486835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930058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09946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279654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119288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9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8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7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1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9545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83133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486837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2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241552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1" indent="0">
              <a:buNone/>
              <a:defRPr sz="1500" b="1"/>
            </a:lvl2pPr>
            <a:lvl3pPr marL="685783" indent="0">
              <a:buNone/>
              <a:defRPr sz="1351" b="1"/>
            </a:lvl3pPr>
            <a:lvl4pPr marL="1028674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1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3065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2026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6150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316570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6902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316570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91" indent="0">
              <a:buNone/>
              <a:defRPr sz="2100"/>
            </a:lvl2pPr>
            <a:lvl3pPr marL="685783" indent="0">
              <a:buNone/>
              <a:defRPr sz="1800"/>
            </a:lvl3pPr>
            <a:lvl4pPr marL="1028674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1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891" indent="0">
              <a:buNone/>
              <a:defRPr sz="1051"/>
            </a:lvl2pPr>
            <a:lvl3pPr marL="685783" indent="0">
              <a:buNone/>
              <a:defRPr sz="900"/>
            </a:lvl3pPr>
            <a:lvl4pPr marL="1028674" indent="0">
              <a:buNone/>
              <a:defRPr sz="751"/>
            </a:lvl4pPr>
            <a:lvl5pPr marL="1371566" indent="0">
              <a:buNone/>
              <a:defRPr sz="751"/>
            </a:lvl5pPr>
            <a:lvl6pPr marL="1714457" indent="0">
              <a:buNone/>
              <a:defRPr sz="751"/>
            </a:lvl6pPr>
            <a:lvl7pPr marL="2057349" indent="0">
              <a:buNone/>
              <a:defRPr sz="751"/>
            </a:lvl7pPr>
            <a:lvl8pPr marL="2400240" indent="0">
              <a:buNone/>
              <a:defRPr sz="751"/>
            </a:lvl8pPr>
            <a:lvl9pPr marL="2743131" indent="0">
              <a:buNone/>
              <a:defRPr sz="75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0077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7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0507FE-F1BE-4EFA-A83F-8B0857555489}" type="datetimeFigureOut">
              <a:rPr lang="fr-FR" smtClean="0"/>
              <a:t>16/02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7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7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8BFE1E-600A-4CD6-A259-5B804BA8743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1492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8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6" indent="-171446" algn="l" defTabSz="685783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3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29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21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3012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904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8" indent="-171446" algn="l" defTabSz="68578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9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83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4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1" algn="l" defTabSz="68578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4" Type="http://schemas.openxmlformats.org/officeDocument/2006/relationships/image" Target="../media/image9.jpe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ZoneTexte 15"/>
          <p:cNvSpPr txBox="1"/>
          <p:nvPr/>
        </p:nvSpPr>
        <p:spPr>
          <a:xfrm>
            <a:off x="1667451" y="3451728"/>
            <a:ext cx="434734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C901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1634979" y="6253564"/>
            <a:ext cx="492443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C1022</a:t>
            </a:r>
          </a:p>
        </p:txBody>
      </p:sp>
      <p:sp>
        <p:nvSpPr>
          <p:cNvPr id="21" name="ZoneTexte 20"/>
          <p:cNvSpPr txBox="1"/>
          <p:nvPr/>
        </p:nvSpPr>
        <p:spPr>
          <a:xfrm>
            <a:off x="1664203" y="647758"/>
            <a:ext cx="441146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266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4759114" y="3451728"/>
            <a:ext cx="620683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PCU-018</a:t>
            </a:r>
          </a:p>
        </p:txBody>
      </p:sp>
      <p:sp>
        <p:nvSpPr>
          <p:cNvPr id="28" name="ZoneTexte 27"/>
          <p:cNvSpPr txBox="1"/>
          <p:nvPr/>
        </p:nvSpPr>
        <p:spPr>
          <a:xfrm>
            <a:off x="4759114" y="647758"/>
            <a:ext cx="620683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PCU-012</a:t>
            </a:r>
          </a:p>
        </p:txBody>
      </p:sp>
      <p:pic>
        <p:nvPicPr>
          <p:cNvPr id="2" name="Image 2" descr="Une image contenant table&#10;&#10;Description générée automatiquement">
            <a:extLst>
              <a:ext uri="{FF2B5EF4-FFF2-40B4-BE49-F238E27FC236}">
                <a16:creationId xmlns:a16="http://schemas.microsoft.com/office/drawing/2014/main" id="{5C05E02A-F5A5-E60A-77BA-055E17EA59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9548" y="226893"/>
            <a:ext cx="599357" cy="543045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857D8518-180B-45EC-DA9A-D33D19D1465C}"/>
              </a:ext>
            </a:extLst>
          </p:cNvPr>
          <p:cNvSpPr txBox="1"/>
          <p:nvPr/>
        </p:nvSpPr>
        <p:spPr>
          <a:xfrm>
            <a:off x="1620120" y="2930271"/>
            <a:ext cx="856712" cy="215444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fr-FR" sz="8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029A88E-AD3E-7DC4-C811-6D996E6BF25A}"/>
              </a:ext>
            </a:extLst>
          </p:cNvPr>
          <p:cNvSpPr txBox="1"/>
          <p:nvPr/>
        </p:nvSpPr>
        <p:spPr>
          <a:xfrm rot="16200000">
            <a:off x="-102931" y="1202844"/>
            <a:ext cx="490840" cy="246221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1000">
                <a:latin typeface="Times New Roman" panose="02020603050405020304" pitchFamily="18" charset="0"/>
                <a:cs typeface="Times New Roman" panose="02020603050405020304" pitchFamily="18" charset="0"/>
              </a:rPr>
              <a:t>CNA 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D255CDF5-8708-2D24-5922-5F3763542391}"/>
              </a:ext>
            </a:extLst>
          </p:cNvPr>
          <p:cNvSpPr txBox="1"/>
          <p:nvPr/>
        </p:nvSpPr>
        <p:spPr>
          <a:xfrm rot="16200000">
            <a:off x="-389134" y="2287003"/>
            <a:ext cx="1069524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quency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9" name="ZoneTexte 1">
            <a:extLst>
              <a:ext uri="{FF2B5EF4-FFF2-40B4-BE49-F238E27FC236}">
                <a16:creationId xmlns:a16="http://schemas.microsoft.com/office/drawing/2014/main" id="{849B14EF-B857-35CC-5F3A-6C214EE82252}"/>
              </a:ext>
            </a:extLst>
          </p:cNvPr>
          <p:cNvSpPr txBox="1"/>
          <p:nvPr/>
        </p:nvSpPr>
        <p:spPr>
          <a:xfrm rot="-5400000">
            <a:off x="-389134" y="5099215"/>
            <a:ext cx="1069524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quency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700D85AB-4877-1F69-F402-907B32C7F93F}"/>
              </a:ext>
            </a:extLst>
          </p:cNvPr>
          <p:cNvSpPr txBox="1"/>
          <p:nvPr/>
        </p:nvSpPr>
        <p:spPr>
          <a:xfrm>
            <a:off x="4880268" y="2943259"/>
            <a:ext cx="856712" cy="215444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fr-FR" sz="8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A94F8EF2-07A7-B1C6-CEF2-E3F67962CDD2}"/>
              </a:ext>
            </a:extLst>
          </p:cNvPr>
          <p:cNvSpPr txBox="1"/>
          <p:nvPr/>
        </p:nvSpPr>
        <p:spPr>
          <a:xfrm rot="16200000">
            <a:off x="-102931" y="4040860"/>
            <a:ext cx="490840" cy="246221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1000">
                <a:latin typeface="Times New Roman" panose="02020603050405020304" pitchFamily="18" charset="0"/>
                <a:cs typeface="Times New Roman" panose="02020603050405020304" pitchFamily="18" charset="0"/>
              </a:rPr>
              <a:t>CNA </a:t>
            </a:r>
          </a:p>
        </p:txBody>
      </p:sp>
      <p:sp>
        <p:nvSpPr>
          <p:cNvPr id="11" name="ZoneTexte 1">
            <a:extLst>
              <a:ext uri="{FF2B5EF4-FFF2-40B4-BE49-F238E27FC236}">
                <a16:creationId xmlns:a16="http://schemas.microsoft.com/office/drawing/2014/main" id="{D6D9CEE8-B12A-56EC-334F-0B625ECE596C}"/>
              </a:ext>
            </a:extLst>
          </p:cNvPr>
          <p:cNvSpPr txBox="1"/>
          <p:nvPr/>
        </p:nvSpPr>
        <p:spPr>
          <a:xfrm rot="-5400000">
            <a:off x="-389134" y="7937231"/>
            <a:ext cx="1069524" cy="230832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ele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900" err="1">
                <a:latin typeface="Times New Roman" panose="02020603050405020304" pitchFamily="18" charset="0"/>
                <a:cs typeface="Times New Roman" panose="02020603050405020304" pitchFamily="18" charset="0"/>
              </a:rPr>
              <a:t>frequency</a:t>
            </a:r>
            <a:r>
              <a:rPr lang="fr-FR" sz="90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9268B0B7-CB92-B617-A633-356E397199B0}"/>
              </a:ext>
            </a:extLst>
          </p:cNvPr>
          <p:cNvSpPr txBox="1"/>
          <p:nvPr/>
        </p:nvSpPr>
        <p:spPr>
          <a:xfrm rot="16200000">
            <a:off x="-102931" y="6865887"/>
            <a:ext cx="490840" cy="246221"/>
          </a:xfrm>
          <a:prstGeom prst="rect">
            <a:avLst/>
          </a:prstGeom>
          <a:solidFill>
            <a:schemeClr val="bg1"/>
          </a:solidFill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fr-FR" sz="1000">
                <a:latin typeface="Times New Roman" panose="02020603050405020304" pitchFamily="18" charset="0"/>
                <a:cs typeface="Times New Roman" panose="02020603050405020304" pitchFamily="18" charset="0"/>
              </a:rPr>
              <a:t>CNA 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A3AFC02-A95A-8CB1-E31D-5C8B73ED8BA1}"/>
              </a:ext>
            </a:extLst>
          </p:cNvPr>
          <p:cNvSpPr txBox="1"/>
          <p:nvPr/>
        </p:nvSpPr>
        <p:spPr>
          <a:xfrm>
            <a:off x="1477245" y="5742310"/>
            <a:ext cx="856712" cy="215444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fr-FR" sz="8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7421630-486A-7F31-A1D9-321E89CE9400}"/>
              </a:ext>
            </a:extLst>
          </p:cNvPr>
          <p:cNvSpPr txBox="1"/>
          <p:nvPr/>
        </p:nvSpPr>
        <p:spPr>
          <a:xfrm>
            <a:off x="4854290" y="5748804"/>
            <a:ext cx="856712" cy="215444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fr-FR" sz="8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6590D960-F6A7-DD65-F7D0-E989A7CFBBAE}"/>
              </a:ext>
            </a:extLst>
          </p:cNvPr>
          <p:cNvSpPr txBox="1"/>
          <p:nvPr/>
        </p:nvSpPr>
        <p:spPr>
          <a:xfrm>
            <a:off x="1516211" y="8547855"/>
            <a:ext cx="856712" cy="215444"/>
          </a:xfrm>
          <a:prstGeom prst="rect">
            <a:avLst/>
          </a:prstGeom>
          <a:solidFill>
            <a:schemeClr val="bg1"/>
          </a:solidFill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fr-FR" sz="800">
                <a:latin typeface="Times New Roman" panose="02020603050405020304" pitchFamily="18" charset="0"/>
                <a:cs typeface="Times New Roman" panose="02020603050405020304" pitchFamily="18" charset="0"/>
              </a:rPr>
              <a:t>Chromosome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68EFCF1E-3CCA-EDB9-B6D7-F6E3F21E43CC}"/>
              </a:ext>
            </a:extLst>
          </p:cNvPr>
          <p:cNvSpPr/>
          <p:nvPr/>
        </p:nvSpPr>
        <p:spPr>
          <a:xfrm>
            <a:off x="1517073" y="7485350"/>
            <a:ext cx="915698" cy="714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6287CF4-FA73-69A3-1406-3DCC8E451B47}"/>
              </a:ext>
            </a:extLst>
          </p:cNvPr>
          <p:cNvSpPr/>
          <p:nvPr/>
        </p:nvSpPr>
        <p:spPr>
          <a:xfrm>
            <a:off x="4822680" y="7465866"/>
            <a:ext cx="915698" cy="714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636251B6-B871-3CBF-A8FD-352DA405EDBB}"/>
              </a:ext>
            </a:extLst>
          </p:cNvPr>
          <p:cNvSpPr/>
          <p:nvPr/>
        </p:nvSpPr>
        <p:spPr>
          <a:xfrm>
            <a:off x="1517072" y="4673310"/>
            <a:ext cx="915698" cy="909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50D88616-593B-A5F3-4900-C2863A4E4548}"/>
              </a:ext>
            </a:extLst>
          </p:cNvPr>
          <p:cNvSpPr/>
          <p:nvPr/>
        </p:nvSpPr>
        <p:spPr>
          <a:xfrm>
            <a:off x="1562532" y="1848281"/>
            <a:ext cx="915698" cy="909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5D73F1C0-2C4B-0A17-7DCD-A63F4314C723}"/>
              </a:ext>
            </a:extLst>
          </p:cNvPr>
          <p:cNvSpPr/>
          <p:nvPr/>
        </p:nvSpPr>
        <p:spPr>
          <a:xfrm>
            <a:off x="4757737" y="1854775"/>
            <a:ext cx="915698" cy="909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ZoneTexte 9">
            <a:extLst>
              <a:ext uri="{FF2B5EF4-FFF2-40B4-BE49-F238E27FC236}">
                <a16:creationId xmlns:a16="http://schemas.microsoft.com/office/drawing/2014/main" id="{6391E0BF-9B58-1F6E-8992-C142CB3BBD31}"/>
              </a:ext>
            </a:extLst>
          </p:cNvPr>
          <p:cNvSpPr txBox="1"/>
          <p:nvPr/>
        </p:nvSpPr>
        <p:spPr>
          <a:xfrm>
            <a:off x="0" y="242546"/>
            <a:ext cx="37011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200" dirty="0">
                <a:latin typeface="Times New Roman"/>
                <a:cs typeface="Times New Roman"/>
              </a:rPr>
              <a:t>A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Image 11" descr="Une image contenant texte, blanc&#10;&#10;Description générée automatiquement">
            <a:extLst>
              <a:ext uri="{FF2B5EF4-FFF2-40B4-BE49-F238E27FC236}">
                <a16:creationId xmlns:a16="http://schemas.microsoft.com/office/drawing/2014/main" id="{FCD7DF61-2ED8-1045-5746-20FD0AAA277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301" y="823595"/>
            <a:ext cx="3212798" cy="2141865"/>
          </a:xfrm>
          <a:prstGeom prst="rect">
            <a:avLst/>
          </a:prstGeom>
        </p:spPr>
      </p:pic>
      <p:pic>
        <p:nvPicPr>
          <p:cNvPr id="32" name="Image 31" descr="Une image contenant texte, carte, blanc&#10;&#10;Description générée automatiquement">
            <a:extLst>
              <a:ext uri="{FF2B5EF4-FFF2-40B4-BE49-F238E27FC236}">
                <a16:creationId xmlns:a16="http://schemas.microsoft.com/office/drawing/2014/main" id="{AB58268B-E3E2-B695-2ACC-325CC505C648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1562" y="829301"/>
            <a:ext cx="3212798" cy="2141865"/>
          </a:xfrm>
          <a:prstGeom prst="rect">
            <a:avLst/>
          </a:prstGeom>
        </p:spPr>
      </p:pic>
      <p:pic>
        <p:nvPicPr>
          <p:cNvPr id="39" name="Image 38" descr="Une image contenant texte, mur, blanc&#10;&#10;Description générée automatiquement">
            <a:extLst>
              <a:ext uri="{FF2B5EF4-FFF2-40B4-BE49-F238E27FC236}">
                <a16:creationId xmlns:a16="http://schemas.microsoft.com/office/drawing/2014/main" id="{90B019B9-A6D1-1E1E-8130-285C368FE76C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044" y="3639579"/>
            <a:ext cx="3230518" cy="2153679"/>
          </a:xfrm>
          <a:prstGeom prst="rect">
            <a:avLst/>
          </a:prstGeom>
        </p:spPr>
      </p:pic>
      <p:pic>
        <p:nvPicPr>
          <p:cNvPr id="41" name="Image 40" descr="Une image contenant texte, blanc&#10;&#10;Description générée automatiquement">
            <a:extLst>
              <a:ext uri="{FF2B5EF4-FFF2-40B4-BE49-F238E27FC236}">
                <a16:creationId xmlns:a16="http://schemas.microsoft.com/office/drawing/2014/main" id="{2F969DF8-0D59-4C5B-5F57-8ED0186B6374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40077" y="3646663"/>
            <a:ext cx="3231499" cy="2154333"/>
          </a:xfrm>
          <a:prstGeom prst="rect">
            <a:avLst/>
          </a:prstGeom>
        </p:spPr>
      </p:pic>
      <p:pic>
        <p:nvPicPr>
          <p:cNvPr id="43" name="Image 42">
            <a:extLst>
              <a:ext uri="{FF2B5EF4-FFF2-40B4-BE49-F238E27FC236}">
                <a16:creationId xmlns:a16="http://schemas.microsoft.com/office/drawing/2014/main" id="{7D6993BA-C454-872C-11E7-CBAA5A1BDA0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965" y="6460463"/>
            <a:ext cx="3230518" cy="2153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9344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73" b="10330"/>
          <a:stretch/>
        </p:blipFill>
        <p:spPr>
          <a:xfrm>
            <a:off x="932147" y="6709451"/>
            <a:ext cx="4210269" cy="1394401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0" y="68378"/>
            <a:ext cx="37011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200" dirty="0">
                <a:latin typeface="Times New Roman"/>
                <a:cs typeface="Times New Roman"/>
              </a:rPr>
              <a:t>B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62" b="9887"/>
          <a:stretch/>
        </p:blipFill>
        <p:spPr>
          <a:xfrm>
            <a:off x="932147" y="646677"/>
            <a:ext cx="4210269" cy="1381824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5178960" y="1101217"/>
            <a:ext cx="12221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G266</a:t>
            </a:r>
          </a:p>
          <a:p>
            <a:r>
              <a:rPr lang="fr-FR" sz="900">
                <a:latin typeface="Arial" panose="020B0604020202020204" pitchFamily="34" charset="0"/>
                <a:cs typeface="Arial" panose="020B0604020202020204" pitchFamily="34" charset="0"/>
              </a:rPr>
              <a:t>30.99 Mut/Mb (1147 mutations/37.01Mb)</a:t>
            </a:r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16" b="9974"/>
          <a:stretch/>
        </p:blipFill>
        <p:spPr>
          <a:xfrm>
            <a:off x="932146" y="2124451"/>
            <a:ext cx="4213325" cy="1377065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5142416" y="2503398"/>
            <a:ext cx="12221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C901</a:t>
            </a:r>
          </a:p>
          <a:p>
            <a:r>
              <a:rPr lang="fr-FR" sz="900">
                <a:latin typeface="Arial" panose="020B0604020202020204" pitchFamily="34" charset="0"/>
                <a:cs typeface="Arial" panose="020B0604020202020204" pitchFamily="34" charset="0"/>
              </a:rPr>
              <a:t>8.46 Mut/Mb (313 mutations/37Mb)</a:t>
            </a:r>
          </a:p>
        </p:txBody>
      </p:sp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567" b="9342"/>
          <a:stretch/>
        </p:blipFill>
        <p:spPr>
          <a:xfrm>
            <a:off x="932145" y="3641228"/>
            <a:ext cx="4210271" cy="1399354"/>
          </a:xfrm>
          <a:prstGeom prst="rect">
            <a:avLst/>
          </a:prstGeom>
        </p:spPr>
      </p:pic>
      <p:sp>
        <p:nvSpPr>
          <p:cNvPr id="15" name="ZoneTexte 14"/>
          <p:cNvSpPr txBox="1"/>
          <p:nvPr/>
        </p:nvSpPr>
        <p:spPr>
          <a:xfrm>
            <a:off x="5142416" y="4012424"/>
            <a:ext cx="12221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C1022</a:t>
            </a:r>
          </a:p>
          <a:p>
            <a:r>
              <a:rPr lang="fr-FR" sz="900">
                <a:latin typeface="Arial" panose="020B0604020202020204" pitchFamily="34" charset="0"/>
                <a:cs typeface="Arial" panose="020B0604020202020204" pitchFamily="34" charset="0"/>
              </a:rPr>
              <a:t>7.64 Mut/Mb (282 mutations/36.93Mb)</a:t>
            </a:r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887" b="8387"/>
          <a:stretch/>
        </p:blipFill>
        <p:spPr>
          <a:xfrm>
            <a:off x="932147" y="5149338"/>
            <a:ext cx="4210269" cy="1426886"/>
          </a:xfrm>
          <a:prstGeom prst="rect">
            <a:avLst/>
          </a:prstGeom>
        </p:spPr>
      </p:pic>
      <p:sp>
        <p:nvSpPr>
          <p:cNvPr id="18" name="ZoneTexte 17"/>
          <p:cNvSpPr txBox="1"/>
          <p:nvPr/>
        </p:nvSpPr>
        <p:spPr>
          <a:xfrm>
            <a:off x="5142416" y="5543185"/>
            <a:ext cx="12221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PCU-012</a:t>
            </a:r>
          </a:p>
          <a:p>
            <a:r>
              <a:rPr lang="fr-FR" sz="900">
                <a:latin typeface="Arial" panose="020B0604020202020204" pitchFamily="34" charset="0"/>
                <a:cs typeface="Arial" panose="020B0604020202020204" pitchFamily="34" charset="0"/>
              </a:rPr>
              <a:t>5.59 Mut/Mb (207 mutations/37.05Mb)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5142416" y="7131045"/>
            <a:ext cx="12221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PCU-018</a:t>
            </a:r>
          </a:p>
          <a:p>
            <a:r>
              <a:rPr lang="fr-FR" sz="900">
                <a:latin typeface="Arial" panose="020B0604020202020204" pitchFamily="34" charset="0"/>
                <a:cs typeface="Arial" panose="020B0604020202020204" pitchFamily="34" charset="0"/>
              </a:rPr>
              <a:t>3.6 Mut/Mb (133 mutations/36.96Mb)</a:t>
            </a:r>
          </a:p>
        </p:txBody>
      </p:sp>
    </p:spTree>
    <p:extLst>
      <p:ext uri="{BB962C8B-B14F-4D97-AF65-F5344CB8AC3E}">
        <p14:creationId xmlns:p14="http://schemas.microsoft.com/office/powerpoint/2010/main" val="26536231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>
            <a:extLst>
              <a:ext uri="{FF2B5EF4-FFF2-40B4-BE49-F238E27FC236}">
                <a16:creationId xmlns:a16="http://schemas.microsoft.com/office/drawing/2014/main" id="{59E6289B-6F7D-49DC-9769-4C7CAE5ACB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5474" y="719536"/>
            <a:ext cx="4525910" cy="3879351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9298A6E8-CCB7-4AD2-A1DF-B12A207AD9EE}"/>
              </a:ext>
            </a:extLst>
          </p:cNvPr>
          <p:cNvSpPr txBox="1"/>
          <p:nvPr/>
        </p:nvSpPr>
        <p:spPr>
          <a:xfrm>
            <a:off x="2943400" y="1211409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>
                <a:solidFill>
                  <a:srgbClr val="F7A9A4"/>
                </a:solidFill>
              </a:rPr>
              <a:t>n=245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0A6C7706-DE93-438D-BCD3-9D2B30F56F79}"/>
              </a:ext>
            </a:extLst>
          </p:cNvPr>
          <p:cNvSpPr txBox="1"/>
          <p:nvPr/>
        </p:nvSpPr>
        <p:spPr>
          <a:xfrm>
            <a:off x="1138931" y="1092140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>
                <a:solidFill>
                  <a:srgbClr val="5B99FF"/>
                </a:solidFill>
              </a:rPr>
              <a:t>n=129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D47005BC-824A-4BA1-BC48-66B63CBE29A3}"/>
              </a:ext>
            </a:extLst>
          </p:cNvPr>
          <p:cNvSpPr txBox="1"/>
          <p:nvPr/>
        </p:nvSpPr>
        <p:spPr>
          <a:xfrm>
            <a:off x="3969867" y="3983091"/>
            <a:ext cx="7729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>
                <a:solidFill>
                  <a:srgbClr val="4ECC73"/>
                </a:solidFill>
              </a:rPr>
              <a:t>n=112</a:t>
            </a:r>
          </a:p>
        </p:txBody>
      </p:sp>
      <p:sp>
        <p:nvSpPr>
          <p:cNvPr id="2" name="ZoneTexte 9">
            <a:extLst>
              <a:ext uri="{FF2B5EF4-FFF2-40B4-BE49-F238E27FC236}">
                <a16:creationId xmlns:a16="http://schemas.microsoft.com/office/drawing/2014/main" id="{986B2059-3DB8-6A20-303F-47AD06C93889}"/>
              </a:ext>
            </a:extLst>
          </p:cNvPr>
          <p:cNvSpPr txBox="1"/>
          <p:nvPr/>
        </p:nvSpPr>
        <p:spPr>
          <a:xfrm>
            <a:off x="0" y="68378"/>
            <a:ext cx="370114" cy="27699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fr-FR" sz="1200" dirty="0">
                <a:latin typeface="Times New Roman"/>
                <a:cs typeface="Times New Roman"/>
              </a:rPr>
              <a:t>C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6068287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FF3963F00EB54E9A3761152733AC6A" ma:contentTypeVersion="4" ma:contentTypeDescription="Create a new document." ma:contentTypeScope="" ma:versionID="e7ffe98eff975e76c50d3452d9430135">
  <xsd:schema xmlns:xsd="http://www.w3.org/2001/XMLSchema" xmlns:xs="http://www.w3.org/2001/XMLSchema" xmlns:p="http://schemas.microsoft.com/office/2006/metadata/properties" xmlns:ns2="b0fabec9-6a62-41a8-94aa-3905766af3d1" xmlns:ns3="e4da75e6-af4f-48ad-8689-e58586a6a97d" targetNamespace="http://schemas.microsoft.com/office/2006/metadata/properties" ma:root="true" ma:fieldsID="b175bc2b261cd1d35f2b535bc3efeb99" ns2:_="" ns3:_="">
    <xsd:import namespace="b0fabec9-6a62-41a8-94aa-3905766af3d1"/>
    <xsd:import namespace="e4da75e6-af4f-48ad-8689-e58586a6a97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0fabec9-6a62-41a8-94aa-3905766af3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da75e6-af4f-48ad-8689-e58586a6a97d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A5BF053-5224-4C22-8E7F-57EA5A507298}">
  <ds:schemaRefs>
    <ds:schemaRef ds:uri="http://www.w3.org/XML/1998/namespace"/>
    <ds:schemaRef ds:uri="http://schemas.microsoft.com/office/2006/metadata/properties"/>
    <ds:schemaRef ds:uri="http://schemas.openxmlformats.org/package/2006/metadata/core-properties"/>
    <ds:schemaRef ds:uri="http://schemas.microsoft.com/office/2006/documentManagement/types"/>
    <ds:schemaRef ds:uri="http://purl.org/dc/elements/1.1/"/>
    <ds:schemaRef ds:uri="b0fabec9-6a62-41a8-94aa-3905766af3d1"/>
    <ds:schemaRef ds:uri="http://purl.org/dc/terms/"/>
    <ds:schemaRef ds:uri="e4da75e6-af4f-48ad-8689-e58586a6a97d"/>
    <ds:schemaRef ds:uri="http://schemas.microsoft.com/office/infopath/2007/PartnerControls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3382A4C7-7331-4B28-88D0-23CB8DA26A7C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5A3B3C1-BFEA-4C7A-922C-1928A570FE9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0fabec9-6a62-41a8-94aa-3905766af3d1"/>
    <ds:schemaRef ds:uri="e4da75e6-af4f-48ad-8689-e58586a6a97d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</TotalTime>
  <Words>86</Words>
  <Application>Microsoft Office PowerPoint</Application>
  <PresentationFormat>Affichage à l'écran (4:3)</PresentationFormat>
  <Paragraphs>32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Yolande Misseri</dc:creator>
  <cp:lastModifiedBy>Nadege Bidan</cp:lastModifiedBy>
  <cp:revision>14</cp:revision>
  <cp:lastPrinted>2022-08-09T08:53:21Z</cp:lastPrinted>
  <dcterms:created xsi:type="dcterms:W3CDTF">2022-08-02T09:59:07Z</dcterms:created>
  <dcterms:modified xsi:type="dcterms:W3CDTF">2023-02-16T13:20:5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FF3963F00EB54E9A3761152733AC6A</vt:lpwstr>
  </property>
  <property fmtid="{D5CDD505-2E9C-101B-9397-08002B2CF9AE}" pid="3" name="MediaServiceImageTags">
    <vt:lpwstr/>
  </property>
</Properties>
</file>